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71"/>
    <p:restoredTop sz="94778"/>
  </p:normalViewPr>
  <p:slideViewPr>
    <p:cSldViewPr snapToGrid="0" snapToObjects="1">
      <p:cViewPr varScale="1">
        <p:scale>
          <a:sx n="107" d="100"/>
          <a:sy n="107" d="100"/>
        </p:scale>
        <p:origin x="7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EAF4672-7832-6347-A167-AA5C5A6FD3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E6EC3AB5-2D5F-7343-89AB-76A1032642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6EA2787-FC77-FF43-B9B6-956170C74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3998182-0688-A14F-889B-8ABB0304F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701C8D7-628D-7440-855E-BA14D1DB0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511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C9C3B0D-46D7-4E4A-9434-027DA8FB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DC8C264-9206-274F-B5A3-B2E60B1A04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3677C3C-64F9-7E4E-97A6-F09D8EDF0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31E6D82-11F7-B847-9050-DAE733246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66D94D5-B348-B94C-BFE8-AEF52F4481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75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613C5B84-C823-384F-AA90-2E20ACBCA7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EFE8BE0-3931-144D-BD46-776C36AF91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0052926-0220-B941-A67A-876D601C2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CB647AA-B846-DC4B-8B84-03AA6AFB9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61D5E59-04D2-9740-8094-3F55954C5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072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E9C27F8-558D-1A49-9489-DB4EB4ADE6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A9C989E-FABA-234E-BF2B-9972CD84EA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9BCA459-C537-F943-8FA7-0CF21EE8B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674750C-3C13-D74A-BFF7-88A6FC8B8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69FBF99-C1C4-774B-B0AB-4D4316577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482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A2C584E-95CE-404A-839F-B252E1F7B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64B1C16-C5C1-3145-AF1B-DFF59FEC93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51AF2AD-BA55-F84E-A752-FA1BA8BA7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3847567-3E59-BD42-A76A-FAF53C0A7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73AFF8D-1F76-E443-8847-65AB77F8E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998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77007A2-9D5D-E643-8701-CEB5D8F51E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DD93DEB-2859-7445-9B6B-FFBA0DF9A9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DAE69C1-5F6B-9A42-9DF2-1EB910928A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C0A33A0-4270-1848-93CD-F7BC9484D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47E66F2-A8AB-6549-B025-6193A6027F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15D78EC-C0E5-934A-B93F-C92A5D740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86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2230B39-1E29-B448-8F87-393EDB6404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304B5B0-38A4-EB4C-BB36-E7AE680DD1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99E4E81-782A-484D-8A5E-FDD3440C41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6F24400A-7D3D-2541-8C3E-09573200B8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17B4A8B6-80BB-A248-9B1D-70341642C0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EE8B0403-C8F3-D742-A000-D12F3DB8B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94B518E-318A-B846-92DC-25B855685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BFD7AFF9-2A32-E441-AB4C-2F16B4255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462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46A7C40-72C2-8F45-B773-8562F8CF3A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2E7856BB-C8E0-B040-8AB2-DFE7F6F6E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E98BC8F6-ABAA-CD4D-94B5-C20F7143A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9997C39A-3175-BB4B-B2C7-320267088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620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77F3B170-1942-DF48-8C2D-C8110C786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D0EDAE08-1DF2-7549-BB22-520F14BBF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BA2D5198-BF08-114C-8CEC-4B09CA922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055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F24F761-95BD-DB45-A15D-39F20083D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7A41998-7DD7-6241-A06A-E87D6E57E6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3A88146-82D0-9B4A-BF6C-B10EE55E6C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DF90893-67A6-B94D-AB73-D7FB1EF36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3617A94-2935-3045-9BBB-C8839A6E3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B08DD4E-2940-D441-BCF4-FA55BF73E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074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F61AA8E-914D-1D47-9D88-5418E0F858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A8247D7F-394A-5543-97F5-6022D5FA49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337C7BA4-7CE8-4A4A-8460-FE77203A57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C730316-1A2C-024E-8B2E-65A1F6246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6B25642-2039-4C4C-96BF-5A584863A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6CCE90D-125C-6545-8C28-8E14A1442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732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0A26F19-D080-1A46-B2DD-CE9987D397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0C880D6-D0C8-8347-BBBC-F8C846CCF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284E070-03AA-F146-8AF7-D792DFA4E2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2958E9-DEA4-FE46-9394-3A478F7B91FF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7747400-444E-1243-B6AF-E739A3DB0F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A20B636-710C-6F47-B2E8-89F90BC96C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E47E0-D393-3A4E-A70B-C2D2324E8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508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F79E85E5-AF70-344F-8CC8-03CDAD014EF9}"/>
              </a:ext>
            </a:extLst>
          </p:cNvPr>
          <p:cNvSpPr txBox="1"/>
          <p:nvPr/>
        </p:nvSpPr>
        <p:spPr>
          <a:xfrm>
            <a:off x="143504" y="101509"/>
            <a:ext cx="13858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 CT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tige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A82D233-DB09-1445-AFC5-6CA4D4E14F6A}"/>
              </a:ext>
            </a:extLst>
          </p:cNvPr>
          <p:cNvSpPr txBox="1"/>
          <p:nvPr/>
        </p:nvSpPr>
        <p:spPr>
          <a:xfrm>
            <a:off x="6225404" y="101509"/>
            <a:ext cx="31003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 Immun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heckpoint regulator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08796CB5-D882-334A-B350-A79BC01B0821}"/>
              </a:ext>
            </a:extLst>
          </p:cNvPr>
          <p:cNvSpPr txBox="1"/>
          <p:nvPr/>
        </p:nvSpPr>
        <p:spPr>
          <a:xfrm>
            <a:off x="6297120" y="4747407"/>
            <a:ext cx="43554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ighly expressed genes are marked in bold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F79E85E5-AF70-344F-8CC8-03CDAD014EF9}"/>
              </a:ext>
            </a:extLst>
          </p:cNvPr>
          <p:cNvSpPr txBox="1"/>
          <p:nvPr/>
        </p:nvSpPr>
        <p:spPr>
          <a:xfrm>
            <a:off x="5517193" y="5562953"/>
            <a:ext cx="6472517" cy="10310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: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eatmap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epresenting relative gene expression withi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ersus control background liver for: A) cancer-testis antigens and B) immune checkpoint inhibitors. Al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ases were sorted by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nBAP1 status and total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scor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previously described, where total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scor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of “0-3” i.e. ‘cold’ tumours are shown as “-” and “4-6” i.e. ‘hot’ tumours are marked “+.”  Key: [indicates tumours from the same patient.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4, R34 &amp; R35 were samples from the same patient, with a 6-year difference between the two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tastasectomie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>
                <a:latin typeface="Arial" panose="020B0604020202020204" pitchFamily="34" charset="0"/>
                <a:cs typeface="Arial" panose="020B0604020202020204" pitchFamily="34" charset="0"/>
              </a:rPr>
              <a:t>CL1 is control liver samples pool 1; CL2 is control liver samples pool </a:t>
            </a:r>
            <a:r>
              <a:rPr lang="en-GB" sz="1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00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xmlns="" id="{204C6564-4970-4A45-8A42-A574E0F9BB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151" y="508246"/>
            <a:ext cx="5219700" cy="5918200"/>
          </a:xfrm>
          <a:prstGeom prst="rect">
            <a:avLst/>
          </a:prstGeom>
        </p:spPr>
      </p:pic>
      <p:pic>
        <p:nvPicPr>
          <p:cNvPr id="11" name="Picture 10" descr="A picture containing sitting, food&#10;&#10;Description automatically generated">
            <a:extLst>
              <a:ext uri="{FF2B5EF4-FFF2-40B4-BE49-F238E27FC236}">
                <a16:creationId xmlns:a16="http://schemas.microsoft.com/office/drawing/2014/main" xmlns="" id="{DD9A6D59-C973-244F-BCFD-E5857D13AA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50910" y="440713"/>
            <a:ext cx="5638800" cy="4229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9206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9</TotalTime>
  <Words>13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at-Pospiech, Dorota</dc:creator>
  <cp:lastModifiedBy>yamini krishna</cp:lastModifiedBy>
  <cp:revision>17</cp:revision>
  <dcterms:created xsi:type="dcterms:W3CDTF">2020-06-15T11:14:19Z</dcterms:created>
  <dcterms:modified xsi:type="dcterms:W3CDTF">2020-09-17T06:50:37Z</dcterms:modified>
</cp:coreProperties>
</file>